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8" d="100"/>
          <a:sy n="88" d="100"/>
        </p:scale>
        <p:origin x="26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954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92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83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759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52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675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872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605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629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675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48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DA9F26-3279-4773-B2E0-27B2A751638A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CC894-4E3B-42F8-9176-86DEB1B7CF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988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87" t="32387" r="40001" b="17140"/>
          <a:stretch/>
        </p:blipFill>
        <p:spPr>
          <a:xfrm>
            <a:off x="2590032" y="1816174"/>
            <a:ext cx="1701800" cy="265646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234" t="46838" r="34217" b="9391"/>
          <a:stretch/>
        </p:blipFill>
        <p:spPr>
          <a:xfrm>
            <a:off x="5321913" y="1866446"/>
            <a:ext cx="1778000" cy="2667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31" t="28496" r="31769" b="19979"/>
          <a:stretch/>
        </p:blipFill>
        <p:spPr>
          <a:xfrm>
            <a:off x="7392013" y="1905957"/>
            <a:ext cx="1689100" cy="262748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684727" y="1974023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84727" y="2195435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1</a:t>
            </a:r>
            <a:r>
              <a:rPr lang="en-US" b="1" dirty="0" smtClean="0">
                <a:solidFill>
                  <a:srgbClr val="FF0000"/>
                </a:solidFill>
              </a:rPr>
              <a:t>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84727" y="245475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0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680044" y="28721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684727" y="312639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37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84727" y="3404578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685101" y="264826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7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701335" y="1681780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solidFill>
                  <a:srgbClr val="FF0000"/>
                </a:solidFill>
              </a:rPr>
              <a:t>kDa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84727" y="358151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684727" y="382269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684727" y="401319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07752" y="2121117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007752" y="234252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1</a:t>
            </a:r>
            <a:r>
              <a:rPr lang="en-US" b="1" dirty="0" smtClean="0">
                <a:solidFill>
                  <a:srgbClr val="FF0000"/>
                </a:solidFill>
              </a:rPr>
              <a:t>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007752" y="260184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0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003069" y="3044663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5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007752" y="32988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37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007752" y="351357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008126" y="279535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7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024360" y="1790774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solidFill>
                  <a:srgbClr val="FF0000"/>
                </a:solidFill>
              </a:rPr>
              <a:t>kDa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007752" y="369050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2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007752" y="38808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5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007752" y="407138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10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2803319" y="3108163"/>
            <a:ext cx="1425013" cy="64026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5550513" y="3452935"/>
            <a:ext cx="1441971" cy="31559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7457722" y="2859793"/>
            <a:ext cx="1188556" cy="38170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TextBox 27"/>
          <p:cNvSpPr txBox="1"/>
          <p:nvPr/>
        </p:nvSpPr>
        <p:spPr>
          <a:xfrm>
            <a:off x="5687844" y="4531719"/>
            <a:ext cx="710451" cy="3508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8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81</a:t>
            </a:r>
            <a:endParaRPr lang="en-US" sz="16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27"/>
          <p:cNvSpPr txBox="1"/>
          <p:nvPr/>
        </p:nvSpPr>
        <p:spPr>
          <a:xfrm>
            <a:off x="7685763" y="4543940"/>
            <a:ext cx="1010213" cy="3508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8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nexin</a:t>
            </a:r>
            <a:endParaRPr lang="en-US" sz="16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27"/>
          <p:cNvSpPr txBox="1"/>
          <p:nvPr/>
        </p:nvSpPr>
        <p:spPr>
          <a:xfrm>
            <a:off x="3095419" y="4470318"/>
            <a:ext cx="710451" cy="3508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8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3</a:t>
            </a:r>
            <a:endParaRPr lang="en-US" sz="16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>
            <a:off x="6043069" y="1713490"/>
            <a:ext cx="794271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5832907" y="1343226"/>
            <a:ext cx="1319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a EXO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Straight Connector 77"/>
          <p:cNvCxnSpPr/>
          <p:nvPr/>
        </p:nvCxnSpPr>
        <p:spPr>
          <a:xfrm flipV="1">
            <a:off x="7616738" y="1713490"/>
            <a:ext cx="877754" cy="544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7376384" y="1352638"/>
            <a:ext cx="1319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a EXO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74908" y="48977"/>
            <a:ext cx="2636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Rectangle 74"/>
          <p:cNvSpPr/>
          <p:nvPr/>
        </p:nvSpPr>
        <p:spPr>
          <a:xfrm>
            <a:off x="4190822" y="274962"/>
            <a:ext cx="31855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ll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edited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ls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Fig.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 flipV="1">
            <a:off x="3151450" y="1685598"/>
            <a:ext cx="877754" cy="544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2911096" y="1324746"/>
            <a:ext cx="13195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a EXO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27"/>
          <p:cNvSpPr txBox="1"/>
          <p:nvPr/>
        </p:nvSpPr>
        <p:spPr>
          <a:xfrm>
            <a:off x="8470774" y="1954918"/>
            <a:ext cx="566181" cy="3508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8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8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</a:t>
            </a:r>
            <a:r>
              <a:rPr lang="en-US" sz="168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6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984318" y="719135"/>
            <a:ext cx="773794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uppl. Fig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1 </a:t>
            </a:r>
            <a:r>
              <a:rPr lang="en-US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howing full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</a:rPr>
              <a:t>length western blot images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s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"original western blots"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3945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59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emanda, Krishna</dc:creator>
  <cp:lastModifiedBy>Rahman, Irfan</cp:lastModifiedBy>
  <cp:revision>13</cp:revision>
  <dcterms:created xsi:type="dcterms:W3CDTF">2020-06-11T21:31:48Z</dcterms:created>
  <dcterms:modified xsi:type="dcterms:W3CDTF">2020-06-12T05:16:03Z</dcterms:modified>
</cp:coreProperties>
</file>